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9144000" cy="6858000" type="screen4x3"/>
  <p:notesSz cx="6858000" cy="9144000"/>
  <p:defaultTextStyle>
    <a:defPPr>
      <a:defRPr lang="ar-EG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94660"/>
  </p:normalViewPr>
  <p:slideViewPr>
    <p:cSldViewPr>
      <p:cViewPr>
        <p:scale>
          <a:sx n="60" d="100"/>
          <a:sy n="60" d="100"/>
        </p:scale>
        <p:origin x="1602" y="1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novo\Desktop\silver%20print\solani%20silver%20manuscript%20figures%20captions\word%20and%20excel%20solani%20silver%20tolerance\Fig-11-9-2019%20(1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9\Faculty%20of%20Science\pap\Mnal\Fig-11-9-201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4'!$K$1</c:f>
              <c:strCache>
                <c:ptCount val="1"/>
                <c:pt idx="0">
                  <c:v>Native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4'!$M$2:$M$13</c:f>
                <c:numCache>
                  <c:formatCode>General</c:formatCode>
                  <c:ptCount val="12"/>
                  <c:pt idx="0">
                    <c:v>0.53254000000000001</c:v>
                  </c:pt>
                  <c:pt idx="1">
                    <c:v>0.44844000000000006</c:v>
                  </c:pt>
                  <c:pt idx="2">
                    <c:v>0.56955999999999996</c:v>
                  </c:pt>
                  <c:pt idx="3">
                    <c:v>0.52915000000000001</c:v>
                  </c:pt>
                  <c:pt idx="4">
                    <c:v>0.28160000000000002</c:v>
                  </c:pt>
                  <c:pt idx="5">
                    <c:v>0.34948000000000068</c:v>
                  </c:pt>
                  <c:pt idx="6">
                    <c:v>0.36056000000000032</c:v>
                  </c:pt>
                  <c:pt idx="7">
                    <c:v>0.45398000000000038</c:v>
                  </c:pt>
                  <c:pt idx="8">
                    <c:v>0.27839000000000008</c:v>
                  </c:pt>
                  <c:pt idx="9">
                    <c:v>0.2</c:v>
                  </c:pt>
                  <c:pt idx="10">
                    <c:v>0.2</c:v>
                  </c:pt>
                  <c:pt idx="11">
                    <c:v>0</c:v>
                  </c:pt>
                </c:numCache>
              </c:numRef>
            </c:plus>
            <c:minus>
              <c:numRef>
                <c:f>'4'!$M$2:$M$13</c:f>
                <c:numCache>
                  <c:formatCode>General</c:formatCode>
                  <c:ptCount val="12"/>
                  <c:pt idx="0">
                    <c:v>0.53254000000000001</c:v>
                  </c:pt>
                  <c:pt idx="1">
                    <c:v>0.44844000000000006</c:v>
                  </c:pt>
                  <c:pt idx="2">
                    <c:v>0.56955999999999996</c:v>
                  </c:pt>
                  <c:pt idx="3">
                    <c:v>0.52915000000000001</c:v>
                  </c:pt>
                  <c:pt idx="4">
                    <c:v>0.28160000000000002</c:v>
                  </c:pt>
                  <c:pt idx="5">
                    <c:v>0.34948000000000068</c:v>
                  </c:pt>
                  <c:pt idx="6">
                    <c:v>0.36056000000000032</c:v>
                  </c:pt>
                  <c:pt idx="7">
                    <c:v>0.45398000000000038</c:v>
                  </c:pt>
                  <c:pt idx="8">
                    <c:v>0.27839000000000008</c:v>
                  </c:pt>
                  <c:pt idx="9">
                    <c:v>0.2</c:v>
                  </c:pt>
                  <c:pt idx="10">
                    <c:v>0.2</c:v>
                  </c:pt>
                  <c:pt idx="11">
                    <c:v>0</c:v>
                  </c:pt>
                </c:numCache>
              </c:numRef>
            </c:minus>
          </c:errBars>
          <c:cat>
            <c:strRef>
              <c:f>'4'!$J$2:$J$13</c:f>
              <c:strCache>
                <c:ptCount val="12"/>
                <c:pt idx="0">
                  <c:v>Control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strCache>
            </c:strRef>
          </c:cat>
          <c:val>
            <c:numRef>
              <c:f>'4'!$K$2:$K$13</c:f>
              <c:numCache>
                <c:formatCode>General</c:formatCode>
                <c:ptCount val="12"/>
                <c:pt idx="0">
                  <c:v>13.450000000000006</c:v>
                </c:pt>
                <c:pt idx="1">
                  <c:v>12.05</c:v>
                </c:pt>
                <c:pt idx="2">
                  <c:v>8.4</c:v>
                </c:pt>
                <c:pt idx="3">
                  <c:v>8.1</c:v>
                </c:pt>
                <c:pt idx="4">
                  <c:v>6.6499999999999995</c:v>
                </c:pt>
                <c:pt idx="5">
                  <c:v>5.8067000000000002</c:v>
                </c:pt>
                <c:pt idx="6">
                  <c:v>3.9</c:v>
                </c:pt>
                <c:pt idx="7">
                  <c:v>3.5</c:v>
                </c:pt>
                <c:pt idx="8">
                  <c:v>3</c:v>
                </c:pt>
                <c:pt idx="9">
                  <c:v>2.1</c:v>
                </c:pt>
                <c:pt idx="10">
                  <c:v>1</c:v>
                </c:pt>
                <c:pt idx="1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330-456B-8297-EFC711DC57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0413440"/>
        <c:axId val="60415360"/>
      </c:lineChart>
      <c:catAx>
        <c:axId val="604134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g(I) concentration (mg/l)</a:t>
                </a:r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lang="en-US" sz="900"/>
            </a:pPr>
            <a:endParaRPr lang="en-US"/>
          </a:p>
        </c:txPr>
        <c:crossAx val="60415360"/>
        <c:crosses val="autoZero"/>
        <c:auto val="1"/>
        <c:lblAlgn val="ctr"/>
        <c:lblOffset val="100"/>
        <c:noMultiLvlLbl val="0"/>
      </c:catAx>
      <c:valAx>
        <c:axId val="604153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Dry weight (g/100 ml broth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60413440"/>
        <c:crosses val="autoZero"/>
        <c:crossBetween val="between"/>
      </c:valAx>
      <c:spPr>
        <a:noFill/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3'!$K$1</c:f>
              <c:strCache>
                <c:ptCount val="1"/>
                <c:pt idx="0">
                  <c:v>Native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3'!$K$11:$K$16</c:f>
                <c:numCache>
                  <c:formatCode>General</c:formatCode>
                  <c:ptCount val="6"/>
                  <c:pt idx="0">
                    <c:v>0.17321000000000031</c:v>
                  </c:pt>
                  <c:pt idx="1">
                    <c:v>0.43589000000000055</c:v>
                  </c:pt>
                  <c:pt idx="2">
                    <c:v>0.51961999999999997</c:v>
                  </c:pt>
                  <c:pt idx="3">
                    <c:v>0.36056000000000032</c:v>
                  </c:pt>
                  <c:pt idx="4">
                    <c:v>0.36056000000000032</c:v>
                  </c:pt>
                  <c:pt idx="5">
                    <c:v>0.36056000000000032</c:v>
                  </c:pt>
                </c:numCache>
              </c:numRef>
            </c:plus>
            <c:minus>
              <c:numRef>
                <c:f>'3'!$K$11:$K$16</c:f>
                <c:numCache>
                  <c:formatCode>General</c:formatCode>
                  <c:ptCount val="6"/>
                  <c:pt idx="0">
                    <c:v>0.17321000000000031</c:v>
                  </c:pt>
                  <c:pt idx="1">
                    <c:v>0.43589000000000055</c:v>
                  </c:pt>
                  <c:pt idx="2">
                    <c:v>0.51961999999999997</c:v>
                  </c:pt>
                  <c:pt idx="3">
                    <c:v>0.36056000000000032</c:v>
                  </c:pt>
                  <c:pt idx="4">
                    <c:v>0.36056000000000032</c:v>
                  </c:pt>
                  <c:pt idx="5">
                    <c:v>0.36056000000000032</c:v>
                  </c:pt>
                </c:numCache>
              </c:numRef>
            </c:minus>
          </c:errBars>
          <c:cat>
            <c:numRef>
              <c:f>'3'!$J$2:$J$7</c:f>
              <c:numCache>
                <c:formatCode>General</c:formatCode>
                <c:ptCount val="6"/>
                <c:pt idx="0">
                  <c:v>5</c:v>
                </c:pt>
                <c:pt idx="1">
                  <c:v>15</c:v>
                </c:pt>
                <c:pt idx="2">
                  <c:v>25</c:v>
                </c:pt>
                <c:pt idx="3">
                  <c:v>35</c:v>
                </c:pt>
                <c:pt idx="4">
                  <c:v>45</c:v>
                </c:pt>
                <c:pt idx="5">
                  <c:v>55</c:v>
                </c:pt>
              </c:numCache>
            </c:numRef>
          </c:cat>
          <c:val>
            <c:numRef>
              <c:f>'3'!$K$2:$K$7</c:f>
              <c:numCache>
                <c:formatCode>General</c:formatCode>
                <c:ptCount val="6"/>
                <c:pt idx="0">
                  <c:v>8.2000000000000011</c:v>
                </c:pt>
                <c:pt idx="1">
                  <c:v>10.5</c:v>
                </c:pt>
                <c:pt idx="2">
                  <c:v>12.4</c:v>
                </c:pt>
                <c:pt idx="3">
                  <c:v>15.8</c:v>
                </c:pt>
                <c:pt idx="4">
                  <c:v>11.2</c:v>
                </c:pt>
                <c:pt idx="5">
                  <c:v>10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824-4D61-9A31-FDDF191EA0E5}"/>
            </c:ext>
          </c:extLst>
        </c:ser>
        <c:ser>
          <c:idx val="1"/>
          <c:order val="1"/>
          <c:tx>
            <c:strRef>
              <c:f>'3'!$L$1</c:f>
              <c:strCache>
                <c:ptCount val="1"/>
                <c:pt idx="0">
                  <c:v>Treated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square"/>
            <c:size val="4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3'!$L$11:$L$16</c:f>
                <c:numCache>
                  <c:formatCode>General</c:formatCode>
                  <c:ptCount val="6"/>
                  <c:pt idx="0">
                    <c:v>0.36056000000000032</c:v>
                  </c:pt>
                  <c:pt idx="1">
                    <c:v>0.65574000000000199</c:v>
                  </c:pt>
                  <c:pt idx="2">
                    <c:v>0.26458000000000031</c:v>
                  </c:pt>
                  <c:pt idx="3">
                    <c:v>0.2</c:v>
                  </c:pt>
                  <c:pt idx="4">
                    <c:v>0.28284000000000031</c:v>
                  </c:pt>
                  <c:pt idx="5">
                    <c:v>0.17321000000000031</c:v>
                  </c:pt>
                </c:numCache>
              </c:numRef>
            </c:plus>
            <c:minus>
              <c:numRef>
                <c:f>'3'!$L$11:$L$16</c:f>
                <c:numCache>
                  <c:formatCode>General</c:formatCode>
                  <c:ptCount val="6"/>
                  <c:pt idx="0">
                    <c:v>0.36056000000000032</c:v>
                  </c:pt>
                  <c:pt idx="1">
                    <c:v>0.65574000000000199</c:v>
                  </c:pt>
                  <c:pt idx="2">
                    <c:v>0.26458000000000031</c:v>
                  </c:pt>
                  <c:pt idx="3">
                    <c:v>0.2</c:v>
                  </c:pt>
                  <c:pt idx="4">
                    <c:v>0.28284000000000031</c:v>
                  </c:pt>
                  <c:pt idx="5">
                    <c:v>0.17321000000000031</c:v>
                  </c:pt>
                </c:numCache>
              </c:numRef>
            </c:minus>
          </c:errBars>
          <c:cat>
            <c:numRef>
              <c:f>'3'!$J$2:$J$7</c:f>
              <c:numCache>
                <c:formatCode>General</c:formatCode>
                <c:ptCount val="6"/>
                <c:pt idx="0">
                  <c:v>5</c:v>
                </c:pt>
                <c:pt idx="1">
                  <c:v>15</c:v>
                </c:pt>
                <c:pt idx="2">
                  <c:v>25</c:v>
                </c:pt>
                <c:pt idx="3">
                  <c:v>35</c:v>
                </c:pt>
                <c:pt idx="4">
                  <c:v>45</c:v>
                </c:pt>
                <c:pt idx="5">
                  <c:v>55</c:v>
                </c:pt>
              </c:numCache>
            </c:numRef>
          </c:cat>
          <c:val>
            <c:numRef>
              <c:f>'3'!$L$2:$L$7</c:f>
              <c:numCache>
                <c:formatCode>General</c:formatCode>
                <c:ptCount val="6"/>
                <c:pt idx="0">
                  <c:v>6</c:v>
                </c:pt>
                <c:pt idx="1">
                  <c:v>7.8</c:v>
                </c:pt>
                <c:pt idx="2">
                  <c:v>9</c:v>
                </c:pt>
                <c:pt idx="3">
                  <c:v>10.3</c:v>
                </c:pt>
                <c:pt idx="4">
                  <c:v>9.3000000000000007</c:v>
                </c:pt>
                <c:pt idx="5">
                  <c:v>7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824-4D61-9A31-FDDF191EA0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918272"/>
        <c:axId val="90934272"/>
      </c:lineChart>
      <c:catAx>
        <c:axId val="909182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Temperature (</a:t>
                </a:r>
                <a:r>
                  <a:rPr lang="en-US" baseline="30000"/>
                  <a:t>o</a:t>
                </a:r>
                <a:r>
                  <a:rPr lang="en-US"/>
                  <a:t>C)</a:t>
                </a:r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90934272"/>
        <c:crosses val="autoZero"/>
        <c:auto val="1"/>
        <c:lblAlgn val="ctr"/>
        <c:lblOffset val="100"/>
        <c:noMultiLvlLbl val="0"/>
      </c:catAx>
      <c:valAx>
        <c:axId val="909342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q (mg/g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90918272"/>
        <c:crosses val="autoZero"/>
        <c:crossBetween val="between"/>
      </c:valAx>
      <c:spPr>
        <a:noFill/>
        <a:ln>
          <a:solidFill>
            <a:sysClr val="windowText" lastClr="000000"/>
          </a:solidFill>
        </a:ln>
      </c:spPr>
    </c:plotArea>
    <c:legend>
      <c:legendPos val="t"/>
      <c:overlay val="0"/>
      <c:spPr>
        <a:noFill/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10'!$K$1</c:f>
              <c:strCache>
                <c:ptCount val="1"/>
                <c:pt idx="0">
                  <c:v>Native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0'!$K$11:$K$19</c:f>
                <c:numCache>
                  <c:formatCode>General</c:formatCode>
                  <c:ptCount val="9"/>
                  <c:pt idx="0">
                    <c:v>0.4</c:v>
                  </c:pt>
                  <c:pt idx="1">
                    <c:v>0.26458000000000031</c:v>
                  </c:pt>
                  <c:pt idx="2">
                    <c:v>0.60000000000000064</c:v>
                  </c:pt>
                  <c:pt idx="3">
                    <c:v>0.43589000000000055</c:v>
                  </c:pt>
                  <c:pt idx="4">
                    <c:v>0.43589000000000055</c:v>
                  </c:pt>
                  <c:pt idx="5">
                    <c:v>0.34641000000000038</c:v>
                  </c:pt>
                  <c:pt idx="6">
                    <c:v>0.30000000000000032</c:v>
                  </c:pt>
                  <c:pt idx="7">
                    <c:v>0.26458000000000031</c:v>
                  </c:pt>
                  <c:pt idx="8">
                    <c:v>0.34641000000000038</c:v>
                  </c:pt>
                </c:numCache>
              </c:numRef>
            </c:plus>
            <c:minus>
              <c:numRef>
                <c:f>'10'!$K$11:$K$19</c:f>
                <c:numCache>
                  <c:formatCode>General</c:formatCode>
                  <c:ptCount val="9"/>
                  <c:pt idx="0">
                    <c:v>0.4</c:v>
                  </c:pt>
                  <c:pt idx="1">
                    <c:v>0.26458000000000031</c:v>
                  </c:pt>
                  <c:pt idx="2">
                    <c:v>0.60000000000000064</c:v>
                  </c:pt>
                  <c:pt idx="3">
                    <c:v>0.43589000000000055</c:v>
                  </c:pt>
                  <c:pt idx="4">
                    <c:v>0.43589000000000055</c:v>
                  </c:pt>
                  <c:pt idx="5">
                    <c:v>0.34641000000000038</c:v>
                  </c:pt>
                  <c:pt idx="6">
                    <c:v>0.30000000000000032</c:v>
                  </c:pt>
                  <c:pt idx="7">
                    <c:v>0.26458000000000031</c:v>
                  </c:pt>
                  <c:pt idx="8">
                    <c:v>0.34641000000000038</c:v>
                  </c:pt>
                </c:numCache>
              </c:numRef>
            </c:minus>
          </c:errBars>
          <c:cat>
            <c:numRef>
              <c:f>'10'!$J$2:$J$10</c:f>
              <c:numCache>
                <c:formatCode>General</c:formatCode>
                <c:ptCount val="9"/>
                <c:pt idx="0">
                  <c:v>8.0000000000000043E-2</c:v>
                </c:pt>
                <c:pt idx="1">
                  <c:v>0.25</c:v>
                </c:pt>
                <c:pt idx="2">
                  <c:v>0.42000000000000032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6</c:v>
                </c:pt>
                <c:pt idx="7">
                  <c:v>12</c:v>
                </c:pt>
                <c:pt idx="8">
                  <c:v>24</c:v>
                </c:pt>
              </c:numCache>
            </c:numRef>
          </c:cat>
          <c:val>
            <c:numRef>
              <c:f>'10'!$K$2:$K$10</c:f>
              <c:numCache>
                <c:formatCode>General</c:formatCode>
                <c:ptCount val="9"/>
                <c:pt idx="0">
                  <c:v>4.9000000000000004</c:v>
                </c:pt>
                <c:pt idx="1">
                  <c:v>8.8000000000000007</c:v>
                </c:pt>
                <c:pt idx="2">
                  <c:v>11.3</c:v>
                </c:pt>
                <c:pt idx="3">
                  <c:v>13.5</c:v>
                </c:pt>
                <c:pt idx="4">
                  <c:v>13.6</c:v>
                </c:pt>
                <c:pt idx="5">
                  <c:v>13.5</c:v>
                </c:pt>
                <c:pt idx="6">
                  <c:v>13.4</c:v>
                </c:pt>
                <c:pt idx="7">
                  <c:v>13.5</c:v>
                </c:pt>
                <c:pt idx="8">
                  <c:v>13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2A9-4C95-8547-FE1212666031}"/>
            </c:ext>
          </c:extLst>
        </c:ser>
        <c:ser>
          <c:idx val="1"/>
          <c:order val="1"/>
          <c:tx>
            <c:strRef>
              <c:f>'10'!$L$1</c:f>
              <c:strCache>
                <c:ptCount val="1"/>
                <c:pt idx="0">
                  <c:v>Treated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square"/>
            <c:size val="4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0'!$L$11:$L$19</c:f>
                <c:numCache>
                  <c:formatCode>General</c:formatCode>
                  <c:ptCount val="9"/>
                  <c:pt idx="0">
                    <c:v>0.30551000000000061</c:v>
                  </c:pt>
                  <c:pt idx="1">
                    <c:v>0.2</c:v>
                  </c:pt>
                  <c:pt idx="2">
                    <c:v>0.1</c:v>
                  </c:pt>
                  <c:pt idx="3">
                    <c:v>0.2</c:v>
                  </c:pt>
                  <c:pt idx="4">
                    <c:v>0.36056000000000032</c:v>
                  </c:pt>
                  <c:pt idx="5">
                    <c:v>7.0710000000000134E-2</c:v>
                  </c:pt>
                  <c:pt idx="6">
                    <c:v>0.15275000000000027</c:v>
                  </c:pt>
                  <c:pt idx="7">
                    <c:v>0.1</c:v>
                  </c:pt>
                  <c:pt idx="8">
                    <c:v>0.1</c:v>
                  </c:pt>
                </c:numCache>
              </c:numRef>
            </c:plus>
            <c:minus>
              <c:numRef>
                <c:f>'10'!$L$11:$L$19</c:f>
                <c:numCache>
                  <c:formatCode>General</c:formatCode>
                  <c:ptCount val="9"/>
                  <c:pt idx="0">
                    <c:v>0.30551000000000061</c:v>
                  </c:pt>
                  <c:pt idx="1">
                    <c:v>0.2</c:v>
                  </c:pt>
                  <c:pt idx="2">
                    <c:v>0.1</c:v>
                  </c:pt>
                  <c:pt idx="3">
                    <c:v>0.2</c:v>
                  </c:pt>
                  <c:pt idx="4">
                    <c:v>0.36056000000000032</c:v>
                  </c:pt>
                  <c:pt idx="5">
                    <c:v>7.0710000000000134E-2</c:v>
                  </c:pt>
                  <c:pt idx="6">
                    <c:v>0.15275000000000027</c:v>
                  </c:pt>
                  <c:pt idx="7">
                    <c:v>0.1</c:v>
                  </c:pt>
                  <c:pt idx="8">
                    <c:v>0.1</c:v>
                  </c:pt>
                </c:numCache>
              </c:numRef>
            </c:minus>
          </c:errBars>
          <c:cat>
            <c:numRef>
              <c:f>'10'!$J$2:$J$10</c:f>
              <c:numCache>
                <c:formatCode>General</c:formatCode>
                <c:ptCount val="9"/>
                <c:pt idx="0">
                  <c:v>8.0000000000000043E-2</c:v>
                </c:pt>
                <c:pt idx="1">
                  <c:v>0.25</c:v>
                </c:pt>
                <c:pt idx="2">
                  <c:v>0.42000000000000032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6</c:v>
                </c:pt>
                <c:pt idx="7">
                  <c:v>12</c:v>
                </c:pt>
                <c:pt idx="8">
                  <c:v>24</c:v>
                </c:pt>
              </c:numCache>
            </c:numRef>
          </c:cat>
          <c:val>
            <c:numRef>
              <c:f>'10'!$L$2:$L$10</c:f>
              <c:numCache>
                <c:formatCode>General</c:formatCode>
                <c:ptCount val="9"/>
                <c:pt idx="0">
                  <c:v>2.2667000000000002</c:v>
                </c:pt>
                <c:pt idx="1">
                  <c:v>4.0999999999999996</c:v>
                </c:pt>
                <c:pt idx="2">
                  <c:v>5.2</c:v>
                </c:pt>
                <c:pt idx="3">
                  <c:v>6.9</c:v>
                </c:pt>
                <c:pt idx="4">
                  <c:v>7.5</c:v>
                </c:pt>
                <c:pt idx="5">
                  <c:v>8.3500000000000068</c:v>
                </c:pt>
                <c:pt idx="6">
                  <c:v>8.0667000000000026</c:v>
                </c:pt>
                <c:pt idx="7">
                  <c:v>8</c:v>
                </c:pt>
                <c:pt idx="8">
                  <c:v>7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2A9-4C95-8547-FE12126660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3729024"/>
        <c:axId val="84083456"/>
      </c:lineChart>
      <c:catAx>
        <c:axId val="837290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Time (h)</a:t>
                </a:r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4083456"/>
        <c:crosses val="autoZero"/>
        <c:auto val="1"/>
        <c:lblAlgn val="ctr"/>
        <c:lblOffset val="100"/>
        <c:noMultiLvlLbl val="0"/>
      </c:catAx>
      <c:valAx>
        <c:axId val="840834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q (mg/g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3729024"/>
        <c:crosses val="autoZero"/>
        <c:crossBetween val="between"/>
      </c:valAx>
      <c:spPr>
        <a:noFill/>
        <a:ln>
          <a:solidFill>
            <a:sysClr val="windowText" lastClr="000000"/>
          </a:solidFill>
        </a:ln>
      </c:spPr>
    </c:plotArea>
    <c:legend>
      <c:legendPos val="t"/>
      <c:overlay val="0"/>
      <c:spPr>
        <a:noFill/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03188405797102"/>
          <c:y val="9.6666666666667275E-2"/>
          <c:w val="0.86991888622618219"/>
          <c:h val="0.737877409123332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Fig-11-9-2019 (1).xlsx]6'!$L$1</c:f>
              <c:strCache>
                <c:ptCount val="1"/>
                <c:pt idx="0">
                  <c:v>A. awamori</c:v>
                </c:pt>
              </c:strCache>
            </c:strRef>
          </c:tx>
          <c:spPr>
            <a:pattFill prst="pct20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-11-9-2019 (1).xlsx]6'!$L$15:$L$26</c:f>
                <c:numCache>
                  <c:formatCode>General</c:formatCode>
                  <c:ptCount val="12"/>
                  <c:pt idx="0">
                    <c:v>0.4</c:v>
                  </c:pt>
                  <c:pt idx="1">
                    <c:v>0.43589000000000028</c:v>
                  </c:pt>
                  <c:pt idx="2">
                    <c:v>0.49508000000000041</c:v>
                  </c:pt>
                  <c:pt idx="3">
                    <c:v>0.52915000000000001</c:v>
                  </c:pt>
                  <c:pt idx="4">
                    <c:v>0.26458000000000026</c:v>
                  </c:pt>
                  <c:pt idx="5">
                    <c:v>0.9</c:v>
                  </c:pt>
                  <c:pt idx="6">
                    <c:v>0.9</c:v>
                  </c:pt>
                  <c:pt idx="7">
                    <c:v>0.1</c:v>
                  </c:pt>
                  <c:pt idx="8">
                    <c:v>0.2</c:v>
                  </c:pt>
                  <c:pt idx="9">
                    <c:v>0.2</c:v>
                  </c:pt>
                </c:numCache>
              </c:numRef>
            </c:plus>
            <c:minus>
              <c:numRef>
                <c:f>'[Fig-11-9-2019 (1).xlsx]6'!$L$15:$L$26</c:f>
                <c:numCache>
                  <c:formatCode>General</c:formatCode>
                  <c:ptCount val="12"/>
                  <c:pt idx="0">
                    <c:v>0.4</c:v>
                  </c:pt>
                  <c:pt idx="1">
                    <c:v>0.43589000000000028</c:v>
                  </c:pt>
                  <c:pt idx="2">
                    <c:v>0.49508000000000041</c:v>
                  </c:pt>
                  <c:pt idx="3">
                    <c:v>0.52915000000000001</c:v>
                  </c:pt>
                  <c:pt idx="4">
                    <c:v>0.26458000000000026</c:v>
                  </c:pt>
                  <c:pt idx="5">
                    <c:v>0.9</c:v>
                  </c:pt>
                  <c:pt idx="6">
                    <c:v>0.9</c:v>
                  </c:pt>
                  <c:pt idx="7">
                    <c:v>0.1</c:v>
                  </c:pt>
                  <c:pt idx="8">
                    <c:v>0.2</c:v>
                  </c:pt>
                  <c:pt idx="9">
                    <c:v>0.2</c:v>
                  </c:pt>
                </c:numCache>
              </c:numRef>
            </c:minus>
          </c:errBars>
          <c:cat>
            <c:numRef>
              <c:f>'[Fig-11-9-2019 (1).xlsx]6'!$K$2:$K$11</c:f>
              <c:numCache>
                <c:formatCode>General</c:formatCode>
                <c:ptCount val="10"/>
                <c:pt idx="0">
                  <c:v>10</c:v>
                </c:pt>
                <c:pt idx="1">
                  <c:v>50</c:v>
                </c:pt>
                <c:pt idx="2">
                  <c:v>100</c:v>
                </c:pt>
                <c:pt idx="3">
                  <c:v>150</c:v>
                </c:pt>
                <c:pt idx="4">
                  <c:v>200</c:v>
                </c:pt>
                <c:pt idx="5">
                  <c:v>250</c:v>
                </c:pt>
                <c:pt idx="6">
                  <c:v>300</c:v>
                </c:pt>
                <c:pt idx="7">
                  <c:v>350</c:v>
                </c:pt>
                <c:pt idx="8">
                  <c:v>400</c:v>
                </c:pt>
                <c:pt idx="9">
                  <c:v>450</c:v>
                </c:pt>
              </c:numCache>
            </c:numRef>
          </c:cat>
          <c:val>
            <c:numRef>
              <c:f>'[Fig-11-9-2019 (1).xlsx]6'!$L$2:$L$11</c:f>
              <c:numCache>
                <c:formatCode>General</c:formatCode>
                <c:ptCount val="10"/>
                <c:pt idx="0">
                  <c:v>17.3</c:v>
                </c:pt>
                <c:pt idx="1">
                  <c:v>29.1</c:v>
                </c:pt>
                <c:pt idx="2">
                  <c:v>70.5</c:v>
                </c:pt>
                <c:pt idx="3">
                  <c:v>72.7</c:v>
                </c:pt>
                <c:pt idx="4">
                  <c:v>73.099999999999994</c:v>
                </c:pt>
                <c:pt idx="5">
                  <c:v>73.400000000000006</c:v>
                </c:pt>
                <c:pt idx="6">
                  <c:v>72.099999999999994</c:v>
                </c:pt>
                <c:pt idx="7">
                  <c:v>72.099999999999994</c:v>
                </c:pt>
                <c:pt idx="8">
                  <c:v>70.099999999999994</c:v>
                </c:pt>
                <c:pt idx="9">
                  <c:v>4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26-449B-A39F-997D96E2C7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573120"/>
        <c:axId val="77751808"/>
      </c:barChart>
      <c:catAx>
        <c:axId val="775731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 sz="1100"/>
                </a:pPr>
                <a:r>
                  <a:rPr lang="en-US" sz="1100" b="1" i="0" baseline="0"/>
                  <a:t>Ag(I) concentration (mg/l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77751808"/>
        <c:crosses val="autoZero"/>
        <c:auto val="1"/>
        <c:lblAlgn val="ctr"/>
        <c:lblOffset val="100"/>
        <c:noMultiLvlLbl val="0"/>
      </c:catAx>
      <c:valAx>
        <c:axId val="777518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Removal %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77573120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0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703188405797102"/>
          <c:y val="0.12841269841269898"/>
          <c:w val="0.86991888622618385"/>
          <c:h val="0.691051599319315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8'!$L$1</c:f>
              <c:strCache>
                <c:ptCount val="1"/>
                <c:pt idx="0">
                  <c:v>Polyphenol oxidase</c:v>
                </c:pt>
              </c:strCache>
            </c:strRef>
          </c:tx>
          <c:spPr>
            <a:pattFill prst="pct20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8'!$L$15:$L$26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5.8000000000000033E-4</c:v>
                  </c:pt>
                  <c:pt idx="2">
                    <c:v>0.17321000000000031</c:v>
                  </c:pt>
                  <c:pt idx="3">
                    <c:v>0.36056000000000032</c:v>
                  </c:pt>
                  <c:pt idx="4">
                    <c:v>0.26458000000000031</c:v>
                  </c:pt>
                  <c:pt idx="5">
                    <c:v>0.1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plus>
            <c:minus>
              <c:numRef>
                <c:f>'8'!$L$15:$L$26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5.8000000000000033E-4</c:v>
                  </c:pt>
                  <c:pt idx="2">
                    <c:v>0.17321000000000031</c:v>
                  </c:pt>
                  <c:pt idx="3">
                    <c:v>0.36056000000000032</c:v>
                  </c:pt>
                  <c:pt idx="4">
                    <c:v>0.26458000000000031</c:v>
                  </c:pt>
                  <c:pt idx="5">
                    <c:v>0.1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minus>
          </c:errBars>
          <c:cat>
            <c:strRef>
              <c:f>'8'!$K$2:$K$13</c:f>
              <c:strCache>
                <c:ptCount val="12"/>
                <c:pt idx="0">
                  <c:v>Control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strCache>
            </c:strRef>
          </c:cat>
          <c:val>
            <c:numRef>
              <c:f>'8'!$L$2:$L$13</c:f>
              <c:numCache>
                <c:formatCode>General</c:formatCode>
                <c:ptCount val="12"/>
                <c:pt idx="0">
                  <c:v>0</c:v>
                </c:pt>
                <c:pt idx="1">
                  <c:v>1.6700000000000034E-2</c:v>
                </c:pt>
                <c:pt idx="2">
                  <c:v>8.3000000000000007</c:v>
                </c:pt>
                <c:pt idx="3">
                  <c:v>10.8</c:v>
                </c:pt>
                <c:pt idx="4">
                  <c:v>17.100000000000001</c:v>
                </c:pt>
                <c:pt idx="5">
                  <c:v>11.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73-42BF-BF93-D89F0D0F7371}"/>
            </c:ext>
          </c:extLst>
        </c:ser>
        <c:ser>
          <c:idx val="1"/>
          <c:order val="1"/>
          <c:tx>
            <c:strRef>
              <c:f>'8'!$M$1</c:f>
              <c:strCache>
                <c:ptCount val="1"/>
                <c:pt idx="0">
                  <c:v>Catalase</c:v>
                </c:pt>
              </c:strCache>
            </c:strRef>
          </c:tx>
          <c:spPr>
            <a:pattFill prst="wdUpDiag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8'!$M$15:$M$26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3.0000000000000048E-3</c:v>
                  </c:pt>
                  <c:pt idx="2">
                    <c:v>8.7179999999999994E-2</c:v>
                  </c:pt>
                  <c:pt idx="3">
                    <c:v>0.2</c:v>
                  </c:pt>
                  <c:pt idx="4">
                    <c:v>0.36056000000000032</c:v>
                  </c:pt>
                  <c:pt idx="5">
                    <c:v>0.17321000000000031</c:v>
                  </c:pt>
                  <c:pt idx="6">
                    <c:v>0.26458000000000031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plus>
            <c:minus>
              <c:numRef>
                <c:f>'8'!$M$15:$M$26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3.0000000000000048E-3</c:v>
                  </c:pt>
                  <c:pt idx="2">
                    <c:v>8.7179999999999994E-2</c:v>
                  </c:pt>
                  <c:pt idx="3">
                    <c:v>0.2</c:v>
                  </c:pt>
                  <c:pt idx="4">
                    <c:v>0.36056000000000032</c:v>
                  </c:pt>
                  <c:pt idx="5">
                    <c:v>0.17321000000000031</c:v>
                  </c:pt>
                  <c:pt idx="6">
                    <c:v>0.26458000000000031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minus>
          </c:errBars>
          <c:cat>
            <c:strRef>
              <c:f>'8'!$K$2:$K$13</c:f>
              <c:strCache>
                <c:ptCount val="12"/>
                <c:pt idx="0">
                  <c:v>Control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strCache>
            </c:strRef>
          </c:cat>
          <c:val>
            <c:numRef>
              <c:f>'8'!$M$2:$M$13</c:f>
              <c:numCache>
                <c:formatCode>General</c:formatCode>
                <c:ptCount val="12"/>
                <c:pt idx="0">
                  <c:v>0</c:v>
                </c:pt>
                <c:pt idx="1">
                  <c:v>2.0000000000000011E-2</c:v>
                </c:pt>
                <c:pt idx="2">
                  <c:v>5.7</c:v>
                </c:pt>
                <c:pt idx="3">
                  <c:v>6.1</c:v>
                </c:pt>
                <c:pt idx="4">
                  <c:v>7.8</c:v>
                </c:pt>
                <c:pt idx="5">
                  <c:v>9.1</c:v>
                </c:pt>
                <c:pt idx="6">
                  <c:v>5.0999999999999996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D73-42BF-BF93-D89F0D0F73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9748352"/>
        <c:axId val="59751040"/>
      </c:barChart>
      <c:catAx>
        <c:axId val="59748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g(I) concentration </a:t>
                </a:r>
                <a:r>
                  <a:rPr lang="en-US" baseline="0"/>
                  <a:t>(mg/l)</a:t>
                </a:r>
                <a:endParaRPr lang="en-US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59751040"/>
        <c:crosses val="autoZero"/>
        <c:auto val="1"/>
        <c:lblAlgn val="ctr"/>
        <c:lblOffset val="100"/>
        <c:noMultiLvlLbl val="0"/>
      </c:catAx>
      <c:valAx>
        <c:axId val="59751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U/mg</a:t>
                </a:r>
                <a:r>
                  <a:rPr lang="en-US" baseline="0"/>
                  <a:t> protein/min</a:t>
                </a:r>
                <a:endParaRPr lang="en-US"/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59748352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legend>
      <c:legendPos val="t"/>
      <c:overlay val="0"/>
      <c:spPr>
        <a:ln w="12700">
          <a:solidFill>
            <a:prstClr val="black"/>
          </a:solidFill>
        </a:ln>
      </c:spPr>
      <c:txPr>
        <a:bodyPr/>
        <a:lstStyle/>
        <a:p>
          <a:pPr>
            <a:defRPr lang="en-US" sz="1100" i="0"/>
          </a:pPr>
          <a:endParaRPr lang="en-US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703188405797102"/>
          <c:y val="0.12841269841269892"/>
          <c:w val="0.86991888622618363"/>
          <c:h val="0.691051599319315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7'!$L$1</c:f>
              <c:strCache>
                <c:ptCount val="1"/>
                <c:pt idx="0">
                  <c:v>Intracellular</c:v>
                </c:pt>
              </c:strCache>
            </c:strRef>
          </c:tx>
          <c:spPr>
            <a:pattFill prst="pct20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7'!$L$15:$L$26</c:f>
                <c:numCache>
                  <c:formatCode>General</c:formatCode>
                  <c:ptCount val="12"/>
                  <c:pt idx="0">
                    <c:v>2.42693</c:v>
                  </c:pt>
                  <c:pt idx="1">
                    <c:v>0.85440000000000005</c:v>
                  </c:pt>
                  <c:pt idx="2">
                    <c:v>1.7435599999999998</c:v>
                  </c:pt>
                  <c:pt idx="3">
                    <c:v>5.0204599999999955</c:v>
                  </c:pt>
                  <c:pt idx="4">
                    <c:v>0.95394000000000123</c:v>
                  </c:pt>
                  <c:pt idx="5">
                    <c:v>0.91652</c:v>
                  </c:pt>
                  <c:pt idx="6">
                    <c:v>1.8734999999999977</c:v>
                  </c:pt>
                  <c:pt idx="7">
                    <c:v>1.90788</c:v>
                  </c:pt>
                  <c:pt idx="8">
                    <c:v>2.3065099999999967</c:v>
                  </c:pt>
                  <c:pt idx="9">
                    <c:v>1.2529999999999974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plus>
            <c:minus>
              <c:numRef>
                <c:f>'7'!$L$15:$L$26</c:f>
                <c:numCache>
                  <c:formatCode>General</c:formatCode>
                  <c:ptCount val="12"/>
                  <c:pt idx="0">
                    <c:v>2.42693</c:v>
                  </c:pt>
                  <c:pt idx="1">
                    <c:v>0.85440000000000005</c:v>
                  </c:pt>
                  <c:pt idx="2">
                    <c:v>1.7435599999999998</c:v>
                  </c:pt>
                  <c:pt idx="3">
                    <c:v>5.0204599999999955</c:v>
                  </c:pt>
                  <c:pt idx="4">
                    <c:v>0.95394000000000123</c:v>
                  </c:pt>
                  <c:pt idx="5">
                    <c:v>0.91652</c:v>
                  </c:pt>
                  <c:pt idx="6">
                    <c:v>1.8734999999999977</c:v>
                  </c:pt>
                  <c:pt idx="7">
                    <c:v>1.90788</c:v>
                  </c:pt>
                  <c:pt idx="8">
                    <c:v>2.3065099999999967</c:v>
                  </c:pt>
                  <c:pt idx="9">
                    <c:v>1.2529999999999974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minus>
          </c:errBars>
          <c:cat>
            <c:numRef>
              <c:f>'7'!$K$2:$K$13</c:f>
              <c:numCache>
                <c:formatCode>General</c:formatCode>
                <c:ptCount val="12"/>
                <c:pt idx="0">
                  <c:v>0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numCache>
            </c:numRef>
          </c:cat>
          <c:val>
            <c:numRef>
              <c:f>'7'!$L$2:$L$13</c:f>
              <c:numCache>
                <c:formatCode>General</c:formatCode>
                <c:ptCount val="12"/>
                <c:pt idx="0">
                  <c:v>100</c:v>
                </c:pt>
                <c:pt idx="1">
                  <c:v>110.1</c:v>
                </c:pt>
                <c:pt idx="2">
                  <c:v>124</c:v>
                </c:pt>
                <c:pt idx="3">
                  <c:v>149.55000000000001</c:v>
                </c:pt>
                <c:pt idx="4">
                  <c:v>200.4</c:v>
                </c:pt>
                <c:pt idx="5">
                  <c:v>236.2</c:v>
                </c:pt>
                <c:pt idx="6">
                  <c:v>272.5</c:v>
                </c:pt>
                <c:pt idx="7">
                  <c:v>180.3</c:v>
                </c:pt>
                <c:pt idx="8">
                  <c:v>90.3</c:v>
                </c:pt>
                <c:pt idx="9">
                  <c:v>42.7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81-4B8E-9917-F5F134694B65}"/>
            </c:ext>
          </c:extLst>
        </c:ser>
        <c:ser>
          <c:idx val="1"/>
          <c:order val="1"/>
          <c:tx>
            <c:strRef>
              <c:f>'7'!$M$1</c:f>
              <c:strCache>
                <c:ptCount val="1"/>
                <c:pt idx="0">
                  <c:v>Extracellular</c:v>
                </c:pt>
              </c:strCache>
            </c:strRef>
          </c:tx>
          <c:spPr>
            <a:pattFill prst="wdUpDiag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7'!$M$15:$M$26</c:f>
                <c:numCache>
                  <c:formatCode>General</c:formatCode>
                  <c:ptCount val="12"/>
                  <c:pt idx="0">
                    <c:v>1.2489999999999977</c:v>
                  </c:pt>
                  <c:pt idx="1">
                    <c:v>0.75498000000000065</c:v>
                  </c:pt>
                  <c:pt idx="2">
                    <c:v>1.8357599999999998</c:v>
                  </c:pt>
                  <c:pt idx="3">
                    <c:v>2.1931699999999998</c:v>
                  </c:pt>
                  <c:pt idx="4">
                    <c:v>1.1789799999999999</c:v>
                  </c:pt>
                  <c:pt idx="5">
                    <c:v>3.4394799999999952</c:v>
                  </c:pt>
                  <c:pt idx="6">
                    <c:v>0.95394000000000123</c:v>
                  </c:pt>
                  <c:pt idx="7">
                    <c:v>2.5514699999999952</c:v>
                  </c:pt>
                  <c:pt idx="8">
                    <c:v>1.0535699999999975</c:v>
                  </c:pt>
                  <c:pt idx="9">
                    <c:v>0.85440000000000005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plus>
            <c:minus>
              <c:numRef>
                <c:f>'7'!$M$15:$M$26</c:f>
                <c:numCache>
                  <c:formatCode>General</c:formatCode>
                  <c:ptCount val="12"/>
                  <c:pt idx="0">
                    <c:v>1.2489999999999977</c:v>
                  </c:pt>
                  <c:pt idx="1">
                    <c:v>0.75498000000000065</c:v>
                  </c:pt>
                  <c:pt idx="2">
                    <c:v>1.8357599999999998</c:v>
                  </c:pt>
                  <c:pt idx="3">
                    <c:v>2.1931699999999998</c:v>
                  </c:pt>
                  <c:pt idx="4">
                    <c:v>1.1789799999999999</c:v>
                  </c:pt>
                  <c:pt idx="5">
                    <c:v>3.4394799999999952</c:v>
                  </c:pt>
                  <c:pt idx="6">
                    <c:v>0.95394000000000123</c:v>
                  </c:pt>
                  <c:pt idx="7">
                    <c:v>2.5514699999999952</c:v>
                  </c:pt>
                  <c:pt idx="8">
                    <c:v>1.0535699999999975</c:v>
                  </c:pt>
                  <c:pt idx="9">
                    <c:v>0.85440000000000005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minus>
          </c:errBars>
          <c:cat>
            <c:numRef>
              <c:f>'7'!$K$2:$K$13</c:f>
              <c:numCache>
                <c:formatCode>General</c:formatCode>
                <c:ptCount val="12"/>
                <c:pt idx="0">
                  <c:v>0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numCache>
            </c:numRef>
          </c:cat>
          <c:val>
            <c:numRef>
              <c:f>'7'!$M$2:$M$13</c:f>
              <c:numCache>
                <c:formatCode>General</c:formatCode>
                <c:ptCount val="12"/>
                <c:pt idx="0">
                  <c:v>92.1</c:v>
                </c:pt>
                <c:pt idx="1">
                  <c:v>94.3</c:v>
                </c:pt>
                <c:pt idx="2">
                  <c:v>96.2</c:v>
                </c:pt>
                <c:pt idx="3">
                  <c:v>100.5</c:v>
                </c:pt>
                <c:pt idx="4">
                  <c:v>260.7</c:v>
                </c:pt>
                <c:pt idx="5">
                  <c:v>303.10000000000002</c:v>
                </c:pt>
                <c:pt idx="6">
                  <c:v>310</c:v>
                </c:pt>
                <c:pt idx="7">
                  <c:v>235</c:v>
                </c:pt>
                <c:pt idx="8">
                  <c:v>40</c:v>
                </c:pt>
                <c:pt idx="9">
                  <c:v>36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C81-4B8E-9917-F5F134694B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481856"/>
        <c:axId val="82243968"/>
      </c:barChart>
      <c:catAx>
        <c:axId val="794818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g(I) concentration </a:t>
                </a:r>
                <a:r>
                  <a:rPr lang="en-US" baseline="0"/>
                  <a:t>(mg/l)</a:t>
                </a:r>
                <a:endParaRPr lang="en-US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2243968"/>
        <c:crosses val="autoZero"/>
        <c:auto val="1"/>
        <c:lblAlgn val="ctr"/>
        <c:lblOffset val="100"/>
        <c:noMultiLvlLbl val="0"/>
      </c:catAx>
      <c:valAx>
        <c:axId val="822439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Thiol content (mM/g)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79481856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legend>
      <c:legendPos val="t"/>
      <c:overlay val="0"/>
      <c:spPr>
        <a:ln w="12700">
          <a:solidFill>
            <a:prstClr val="black"/>
          </a:solidFill>
        </a:ln>
      </c:spPr>
      <c:txPr>
        <a:bodyPr/>
        <a:lstStyle/>
        <a:p>
          <a:pPr>
            <a:defRPr lang="en-US" sz="1100" i="0"/>
          </a:pPr>
          <a:endParaRPr lang="en-US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703188405797102"/>
          <c:y val="0.12841269841269909"/>
          <c:w val="0.86991888622618463"/>
          <c:h val="0.691051599319315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1'!$L$1</c:f>
              <c:strCache>
                <c:ptCount val="1"/>
                <c:pt idx="0">
                  <c:v>Intracellular</c:v>
                </c:pt>
              </c:strCache>
            </c:strRef>
          </c:tx>
          <c:spPr>
            <a:pattFill prst="pct20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1'!$L$15:$L$26</c:f>
                <c:numCache>
                  <c:formatCode>General</c:formatCode>
                  <c:ptCount val="12"/>
                  <c:pt idx="0">
                    <c:v>1.2489999999999977</c:v>
                  </c:pt>
                  <c:pt idx="1">
                    <c:v>1.0535699999999975</c:v>
                  </c:pt>
                  <c:pt idx="2">
                    <c:v>1.4933199999999998</c:v>
                  </c:pt>
                  <c:pt idx="3">
                    <c:v>1.4</c:v>
                  </c:pt>
                  <c:pt idx="4">
                    <c:v>1.5099699999999971</c:v>
                  </c:pt>
                  <c:pt idx="5">
                    <c:v>2.4433600000000002</c:v>
                  </c:pt>
                  <c:pt idx="6">
                    <c:v>0.55678000000000005</c:v>
                  </c:pt>
                  <c:pt idx="7">
                    <c:v>1.1269400000000001</c:v>
                  </c:pt>
                  <c:pt idx="8">
                    <c:v>1.9313199999999999</c:v>
                  </c:pt>
                  <c:pt idx="9">
                    <c:v>0.98489000000000004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plus>
            <c:minus>
              <c:numRef>
                <c:f>'11'!$L$15:$L$26</c:f>
                <c:numCache>
                  <c:formatCode>General</c:formatCode>
                  <c:ptCount val="12"/>
                  <c:pt idx="0">
                    <c:v>1.2489999999999977</c:v>
                  </c:pt>
                  <c:pt idx="1">
                    <c:v>1.0535699999999975</c:v>
                  </c:pt>
                  <c:pt idx="2">
                    <c:v>1.4933199999999998</c:v>
                  </c:pt>
                  <c:pt idx="3">
                    <c:v>1.4</c:v>
                  </c:pt>
                  <c:pt idx="4">
                    <c:v>1.5099699999999971</c:v>
                  </c:pt>
                  <c:pt idx="5">
                    <c:v>2.4433600000000002</c:v>
                  </c:pt>
                  <c:pt idx="6">
                    <c:v>0.55678000000000005</c:v>
                  </c:pt>
                  <c:pt idx="7">
                    <c:v>1.1269400000000001</c:v>
                  </c:pt>
                  <c:pt idx="8">
                    <c:v>1.9313199999999999</c:v>
                  </c:pt>
                  <c:pt idx="9">
                    <c:v>0.98489000000000004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minus>
          </c:errBars>
          <c:cat>
            <c:numRef>
              <c:f>'11'!$K$2:$K$13</c:f>
              <c:numCache>
                <c:formatCode>General</c:formatCode>
                <c:ptCount val="12"/>
                <c:pt idx="0">
                  <c:v>0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numCache>
            </c:numRef>
          </c:cat>
          <c:val>
            <c:numRef>
              <c:f>'11'!$L$2:$L$13</c:f>
              <c:numCache>
                <c:formatCode>General</c:formatCode>
                <c:ptCount val="12"/>
                <c:pt idx="0">
                  <c:v>50.3</c:v>
                </c:pt>
                <c:pt idx="1">
                  <c:v>56.9</c:v>
                </c:pt>
                <c:pt idx="2">
                  <c:v>65.8</c:v>
                </c:pt>
                <c:pt idx="3">
                  <c:v>70.900000000000006</c:v>
                </c:pt>
                <c:pt idx="4">
                  <c:v>94.1</c:v>
                </c:pt>
                <c:pt idx="5">
                  <c:v>100.2</c:v>
                </c:pt>
                <c:pt idx="6">
                  <c:v>103.4</c:v>
                </c:pt>
                <c:pt idx="7">
                  <c:v>107.3</c:v>
                </c:pt>
                <c:pt idx="8">
                  <c:v>33.1</c:v>
                </c:pt>
                <c:pt idx="9">
                  <c:v>12.2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EB-4936-BA32-1905D01479C3}"/>
            </c:ext>
          </c:extLst>
        </c:ser>
        <c:ser>
          <c:idx val="1"/>
          <c:order val="1"/>
          <c:tx>
            <c:strRef>
              <c:f>'11'!$M$1</c:f>
              <c:strCache>
                <c:ptCount val="1"/>
                <c:pt idx="0">
                  <c:v>Extracellular</c:v>
                </c:pt>
              </c:strCache>
            </c:strRef>
          </c:tx>
          <c:spPr>
            <a:pattFill prst="wdUpDiag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11'!$M$15:$M$26</c:f>
                <c:numCache>
                  <c:formatCode>General</c:formatCode>
                  <c:ptCount val="12"/>
                  <c:pt idx="0">
                    <c:v>0.72111000000000003</c:v>
                  </c:pt>
                  <c:pt idx="1">
                    <c:v>0.88882000000000005</c:v>
                  </c:pt>
                  <c:pt idx="2">
                    <c:v>0.70000000000000062</c:v>
                  </c:pt>
                  <c:pt idx="3">
                    <c:v>1.0816699999999975</c:v>
                  </c:pt>
                  <c:pt idx="4">
                    <c:v>0.45826</c:v>
                  </c:pt>
                  <c:pt idx="5">
                    <c:v>1.6093500000000001</c:v>
                  </c:pt>
                  <c:pt idx="6">
                    <c:v>2.0506099999999967</c:v>
                  </c:pt>
                  <c:pt idx="7">
                    <c:v>0.68069000000000124</c:v>
                  </c:pt>
                  <c:pt idx="8">
                    <c:v>1.27671</c:v>
                  </c:pt>
                  <c:pt idx="9">
                    <c:v>0.75498000000000065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plus>
            <c:minus>
              <c:numRef>
                <c:f>'11'!$M$15:$M$26</c:f>
                <c:numCache>
                  <c:formatCode>General</c:formatCode>
                  <c:ptCount val="12"/>
                  <c:pt idx="0">
                    <c:v>0.72111000000000003</c:v>
                  </c:pt>
                  <c:pt idx="1">
                    <c:v>0.88882000000000005</c:v>
                  </c:pt>
                  <c:pt idx="2">
                    <c:v>0.70000000000000062</c:v>
                  </c:pt>
                  <c:pt idx="3">
                    <c:v>1.0816699999999975</c:v>
                  </c:pt>
                  <c:pt idx="4">
                    <c:v>0.45826</c:v>
                  </c:pt>
                  <c:pt idx="5">
                    <c:v>1.6093500000000001</c:v>
                  </c:pt>
                  <c:pt idx="6">
                    <c:v>2.0506099999999967</c:v>
                  </c:pt>
                  <c:pt idx="7">
                    <c:v>0.68069000000000124</c:v>
                  </c:pt>
                  <c:pt idx="8">
                    <c:v>1.27671</c:v>
                  </c:pt>
                  <c:pt idx="9">
                    <c:v>0.75498000000000065</c:v>
                  </c:pt>
                  <c:pt idx="10">
                    <c:v>0</c:v>
                  </c:pt>
                  <c:pt idx="11">
                    <c:v>0</c:v>
                  </c:pt>
                </c:numCache>
              </c:numRef>
            </c:minus>
          </c:errBars>
          <c:cat>
            <c:numRef>
              <c:f>'11'!$K$2:$K$13</c:f>
              <c:numCache>
                <c:formatCode>General</c:formatCode>
                <c:ptCount val="12"/>
                <c:pt idx="0">
                  <c:v>0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numCache>
            </c:numRef>
          </c:cat>
          <c:val>
            <c:numRef>
              <c:f>'11'!$M$2:$M$13</c:f>
              <c:numCache>
                <c:formatCode>General</c:formatCode>
                <c:ptCount val="12"/>
                <c:pt idx="0">
                  <c:v>22.7</c:v>
                </c:pt>
                <c:pt idx="1">
                  <c:v>41.5</c:v>
                </c:pt>
                <c:pt idx="2">
                  <c:v>70.3</c:v>
                </c:pt>
                <c:pt idx="3">
                  <c:v>79.400000000000006</c:v>
                </c:pt>
                <c:pt idx="4">
                  <c:v>85.5</c:v>
                </c:pt>
                <c:pt idx="5">
                  <c:v>110.3</c:v>
                </c:pt>
                <c:pt idx="6">
                  <c:v>116.45</c:v>
                </c:pt>
                <c:pt idx="7">
                  <c:v>120.86669999999999</c:v>
                </c:pt>
                <c:pt idx="8">
                  <c:v>21.1</c:v>
                </c:pt>
                <c:pt idx="9">
                  <c:v>10.5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FEB-4936-BA32-1905D01479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671040"/>
        <c:axId val="77681792"/>
      </c:barChart>
      <c:catAx>
        <c:axId val="776710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g(I) concentration </a:t>
                </a:r>
                <a:r>
                  <a:rPr lang="en-US" baseline="0"/>
                  <a:t>(mg/l)</a:t>
                </a:r>
                <a:endParaRPr lang="en-US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77681792"/>
        <c:crosses val="autoZero"/>
        <c:auto val="1"/>
        <c:lblAlgn val="ctr"/>
        <c:lblOffset val="100"/>
        <c:noMultiLvlLbl val="0"/>
      </c:catAx>
      <c:valAx>
        <c:axId val="776817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Protein ccontent (mg/g dry weight)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77671040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legend>
      <c:legendPos val="t"/>
      <c:overlay val="0"/>
      <c:spPr>
        <a:ln w="12700">
          <a:solidFill>
            <a:prstClr val="black"/>
          </a:solidFill>
        </a:ln>
      </c:spPr>
      <c:txPr>
        <a:bodyPr/>
        <a:lstStyle/>
        <a:p>
          <a:pPr>
            <a:defRPr lang="en-US" sz="1100" i="0"/>
          </a:pPr>
          <a:endParaRPr lang="en-US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703188405797102"/>
          <c:y val="0.12841269841269898"/>
          <c:w val="0.86991888622618385"/>
          <c:h val="0.691051599319315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9'!$L$1</c:f>
              <c:strCache>
                <c:ptCount val="1"/>
                <c:pt idx="0">
                  <c:v>MDA</c:v>
                </c:pt>
              </c:strCache>
            </c:strRef>
          </c:tx>
          <c:spPr>
            <a:pattFill prst="pct20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9'!$L$15:$L$26</c:f>
                <c:numCache>
                  <c:formatCode>General</c:formatCode>
                  <c:ptCount val="12"/>
                </c:numCache>
              </c:numRef>
            </c:plus>
            <c:minus>
              <c:numRef>
                <c:f>'9'!$L$15:$L$26</c:f>
                <c:numCache>
                  <c:formatCode>General</c:formatCode>
                  <c:ptCount val="12"/>
                </c:numCache>
              </c:numRef>
            </c:minus>
          </c:errBars>
          <c:cat>
            <c:numRef>
              <c:f>'9'!$K$2:$K$13</c:f>
              <c:numCache>
                <c:formatCode>General</c:formatCode>
                <c:ptCount val="12"/>
                <c:pt idx="0">
                  <c:v>0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numCache>
            </c:numRef>
          </c:cat>
          <c:val>
            <c:numRef>
              <c:f>'9'!$L$2:$L$13</c:f>
              <c:numCache>
                <c:formatCode>General</c:formatCode>
                <c:ptCount val="12"/>
                <c:pt idx="0">
                  <c:v>3.5</c:v>
                </c:pt>
                <c:pt idx="1">
                  <c:v>4.5</c:v>
                </c:pt>
                <c:pt idx="2">
                  <c:v>4.7</c:v>
                </c:pt>
                <c:pt idx="3">
                  <c:v>5.0999999999999996</c:v>
                </c:pt>
                <c:pt idx="4">
                  <c:v>5.4</c:v>
                </c:pt>
                <c:pt idx="5">
                  <c:v>6.5</c:v>
                </c:pt>
                <c:pt idx="6">
                  <c:v>7.8</c:v>
                </c:pt>
                <c:pt idx="7">
                  <c:v>8.5</c:v>
                </c:pt>
                <c:pt idx="8">
                  <c:v>6.2</c:v>
                </c:pt>
                <c:pt idx="9">
                  <c:v>4.7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C3-4A94-A207-54E2D14ADE96}"/>
            </c:ext>
          </c:extLst>
        </c:ser>
        <c:ser>
          <c:idx val="1"/>
          <c:order val="1"/>
          <c:tx>
            <c:strRef>
              <c:f>'9'!$M$1</c:f>
              <c:strCache>
                <c:ptCount val="1"/>
                <c:pt idx="0">
                  <c:v>H2O2</c:v>
                </c:pt>
              </c:strCache>
            </c:strRef>
          </c:tx>
          <c:spPr>
            <a:pattFill prst="wdUpDiag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9'!$M$15:$M$26</c:f>
                <c:numCache>
                  <c:formatCode>General</c:formatCode>
                  <c:ptCount val="12"/>
                </c:numCache>
              </c:numRef>
            </c:plus>
            <c:minus>
              <c:numRef>
                <c:f>'9'!$M$15:$M$26</c:f>
                <c:numCache>
                  <c:formatCode>General</c:formatCode>
                  <c:ptCount val="12"/>
                </c:numCache>
              </c:numRef>
            </c:minus>
          </c:errBars>
          <c:cat>
            <c:numRef>
              <c:f>'9'!$K$2:$K$13</c:f>
              <c:numCache>
                <c:formatCode>General</c:formatCode>
                <c:ptCount val="12"/>
                <c:pt idx="0">
                  <c:v>0</c:v>
                </c:pt>
                <c:pt idx="1">
                  <c:v>10</c:v>
                </c:pt>
                <c:pt idx="2">
                  <c:v>50</c:v>
                </c:pt>
                <c:pt idx="3">
                  <c:v>100</c:v>
                </c:pt>
                <c:pt idx="4">
                  <c:v>150</c:v>
                </c:pt>
                <c:pt idx="5">
                  <c:v>200</c:v>
                </c:pt>
                <c:pt idx="6">
                  <c:v>250</c:v>
                </c:pt>
                <c:pt idx="7">
                  <c:v>300</c:v>
                </c:pt>
                <c:pt idx="8">
                  <c:v>350</c:v>
                </c:pt>
                <c:pt idx="9">
                  <c:v>400</c:v>
                </c:pt>
                <c:pt idx="10">
                  <c:v>450</c:v>
                </c:pt>
                <c:pt idx="11">
                  <c:v>500</c:v>
                </c:pt>
              </c:numCache>
            </c:numRef>
          </c:cat>
          <c:val>
            <c:numRef>
              <c:f>'9'!$M$2:$M$13</c:f>
              <c:numCache>
                <c:formatCode>General</c:formatCode>
                <c:ptCount val="12"/>
                <c:pt idx="0">
                  <c:v>4.09</c:v>
                </c:pt>
                <c:pt idx="1">
                  <c:v>5.1599999999999975</c:v>
                </c:pt>
                <c:pt idx="2">
                  <c:v>7.89</c:v>
                </c:pt>
                <c:pt idx="3">
                  <c:v>10.200000000000001</c:v>
                </c:pt>
                <c:pt idx="4">
                  <c:v>19.100000000000001</c:v>
                </c:pt>
                <c:pt idx="5">
                  <c:v>22.8</c:v>
                </c:pt>
                <c:pt idx="6">
                  <c:v>24.5</c:v>
                </c:pt>
                <c:pt idx="7">
                  <c:v>28.1</c:v>
                </c:pt>
                <c:pt idx="8">
                  <c:v>22.1</c:v>
                </c:pt>
                <c:pt idx="9">
                  <c:v>15.7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C3-4A94-A207-54E2D14AD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4345600"/>
        <c:axId val="84347520"/>
      </c:barChart>
      <c:catAx>
        <c:axId val="843456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g(I) concentration </a:t>
                </a:r>
                <a:r>
                  <a:rPr lang="en-US" baseline="0"/>
                  <a:t>(mg/l)</a:t>
                </a:r>
                <a:endParaRPr lang="en-US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4347520"/>
        <c:crosses val="autoZero"/>
        <c:auto val="1"/>
        <c:lblAlgn val="ctr"/>
        <c:lblOffset val="100"/>
        <c:noMultiLvlLbl val="0"/>
      </c:catAx>
      <c:valAx>
        <c:axId val="843475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mmol/g protein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4345600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legend>
      <c:legendPos val="t"/>
      <c:overlay val="0"/>
      <c:spPr>
        <a:ln w="12700">
          <a:solidFill>
            <a:prstClr val="black"/>
          </a:solidFill>
        </a:ln>
      </c:spPr>
      <c:txPr>
        <a:bodyPr/>
        <a:lstStyle/>
        <a:p>
          <a:pPr>
            <a:defRPr lang="en-US" sz="1100" i="0"/>
          </a:pPr>
          <a:endParaRPr lang="en-US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5'!$K$1</c:f>
              <c:strCache>
                <c:ptCount val="1"/>
                <c:pt idx="0">
                  <c:v>Native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5'!$K$11:$K$16</c:f>
                <c:numCache>
                  <c:formatCode>General</c:formatCode>
                  <c:ptCount val="6"/>
                  <c:pt idx="0">
                    <c:v>0.22605</c:v>
                  </c:pt>
                  <c:pt idx="1">
                    <c:v>0.32787000000000105</c:v>
                  </c:pt>
                  <c:pt idx="2">
                    <c:v>0.45826</c:v>
                  </c:pt>
                  <c:pt idx="3">
                    <c:v>0.45826</c:v>
                  </c:pt>
                  <c:pt idx="4">
                    <c:v>0.2</c:v>
                  </c:pt>
                </c:numCache>
              </c:numRef>
            </c:plus>
            <c:minus>
              <c:numRef>
                <c:f>'5'!$K$11:$K$16</c:f>
                <c:numCache>
                  <c:formatCode>General</c:formatCode>
                  <c:ptCount val="6"/>
                  <c:pt idx="0">
                    <c:v>0.22605</c:v>
                  </c:pt>
                  <c:pt idx="1">
                    <c:v>0.32787000000000105</c:v>
                  </c:pt>
                  <c:pt idx="2">
                    <c:v>0.45826</c:v>
                  </c:pt>
                  <c:pt idx="3">
                    <c:v>0.45826</c:v>
                  </c:pt>
                  <c:pt idx="4">
                    <c:v>0.2</c:v>
                  </c:pt>
                </c:numCache>
              </c:numRef>
            </c:minus>
          </c:errBars>
          <c:cat>
            <c:numRef>
              <c:f>'5'!$J$2:$J$6</c:f>
              <c:numCache>
                <c:formatCode>General</c:formatCod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</c:numCache>
            </c:numRef>
          </c:cat>
          <c:val>
            <c:numRef>
              <c:f>'5'!$K$2:$K$6</c:f>
              <c:numCache>
                <c:formatCode>General</c:formatCode>
                <c:ptCount val="5"/>
                <c:pt idx="0">
                  <c:v>5.1899999999999995</c:v>
                </c:pt>
                <c:pt idx="1">
                  <c:v>7.8</c:v>
                </c:pt>
                <c:pt idx="2">
                  <c:v>10.200000000000001</c:v>
                </c:pt>
                <c:pt idx="3">
                  <c:v>12.4</c:v>
                </c:pt>
                <c:pt idx="4">
                  <c:v>9.20000000000000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50E-4BD2-B868-F6DC4DCF0BD0}"/>
            </c:ext>
          </c:extLst>
        </c:ser>
        <c:ser>
          <c:idx val="1"/>
          <c:order val="1"/>
          <c:tx>
            <c:strRef>
              <c:f>'5'!$L$1</c:f>
              <c:strCache>
                <c:ptCount val="1"/>
                <c:pt idx="0">
                  <c:v>Treated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square"/>
            <c:size val="4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5'!$L$11:$L$16</c:f>
                <c:numCache>
                  <c:formatCode>General</c:formatCode>
                  <c:ptCount val="6"/>
                  <c:pt idx="0">
                    <c:v>0.35019</c:v>
                  </c:pt>
                  <c:pt idx="1">
                    <c:v>0.19519</c:v>
                  </c:pt>
                  <c:pt idx="2">
                    <c:v>0.17321000000000031</c:v>
                  </c:pt>
                  <c:pt idx="3">
                    <c:v>0.17321000000000031</c:v>
                  </c:pt>
                  <c:pt idx="4">
                    <c:v>0.36056000000000032</c:v>
                  </c:pt>
                </c:numCache>
              </c:numRef>
            </c:plus>
            <c:minus>
              <c:numRef>
                <c:f>'5'!$L$11:$L$16</c:f>
                <c:numCache>
                  <c:formatCode>General</c:formatCode>
                  <c:ptCount val="6"/>
                  <c:pt idx="0">
                    <c:v>0.35019</c:v>
                  </c:pt>
                  <c:pt idx="1">
                    <c:v>0.19519</c:v>
                  </c:pt>
                  <c:pt idx="2">
                    <c:v>0.17321000000000031</c:v>
                  </c:pt>
                  <c:pt idx="3">
                    <c:v>0.17321000000000031</c:v>
                  </c:pt>
                  <c:pt idx="4">
                    <c:v>0.36056000000000032</c:v>
                  </c:pt>
                </c:numCache>
              </c:numRef>
            </c:minus>
          </c:errBars>
          <c:cat>
            <c:numRef>
              <c:f>'5'!$J$2:$J$6</c:f>
              <c:numCache>
                <c:formatCode>General</c:formatCode>
                <c:ptCount val="5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</c:numCache>
            </c:numRef>
          </c:cat>
          <c:val>
            <c:numRef>
              <c:f>'5'!$L$2:$L$6</c:f>
              <c:numCache>
                <c:formatCode>General</c:formatCode>
                <c:ptCount val="5"/>
                <c:pt idx="0">
                  <c:v>4.2567000000000004</c:v>
                </c:pt>
                <c:pt idx="1">
                  <c:v>5.1099999999999985</c:v>
                </c:pt>
                <c:pt idx="2">
                  <c:v>6.1</c:v>
                </c:pt>
                <c:pt idx="3">
                  <c:v>7.5</c:v>
                </c:pt>
                <c:pt idx="4">
                  <c:v>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50E-4BD2-B868-F6DC4DCF0B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407040"/>
        <c:axId val="84408960"/>
      </c:lineChart>
      <c:catAx>
        <c:axId val="844070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pH</a:t>
                </a:r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4408960"/>
        <c:crosses val="autoZero"/>
        <c:auto val="1"/>
        <c:lblAlgn val="ctr"/>
        <c:lblOffset val="100"/>
        <c:noMultiLvlLbl val="0"/>
      </c:catAx>
      <c:valAx>
        <c:axId val="844089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q (mg/g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4407040"/>
        <c:crosses val="autoZero"/>
        <c:crossBetween val="between"/>
      </c:valAx>
      <c:spPr>
        <a:noFill/>
        <a:ln>
          <a:solidFill>
            <a:sysClr val="windowText" lastClr="000000"/>
          </a:solidFill>
        </a:ln>
      </c:spPr>
    </c:plotArea>
    <c:legend>
      <c:legendPos val="t"/>
      <c:overlay val="0"/>
      <c:spPr>
        <a:noFill/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1'!$K$1</c:f>
              <c:strCache>
                <c:ptCount val="1"/>
                <c:pt idx="0">
                  <c:v>Native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'!$K$11:$K$16</c:f>
                <c:numCache>
                  <c:formatCode>General</c:formatCode>
                  <c:ptCount val="6"/>
                  <c:pt idx="0">
                    <c:v>0.35019</c:v>
                  </c:pt>
                  <c:pt idx="1">
                    <c:v>0.25357000000000002</c:v>
                  </c:pt>
                  <c:pt idx="2">
                    <c:v>0.18520000000000031</c:v>
                  </c:pt>
                  <c:pt idx="3">
                    <c:v>0.18520000000000031</c:v>
                  </c:pt>
                  <c:pt idx="4">
                    <c:v>0.25166000000000005</c:v>
                  </c:pt>
                  <c:pt idx="5">
                    <c:v>6.0830000000000023E-2</c:v>
                  </c:pt>
                </c:numCache>
              </c:numRef>
            </c:plus>
            <c:minus>
              <c:numRef>
                <c:f>'1'!$K$11:$K$16</c:f>
                <c:numCache>
                  <c:formatCode>General</c:formatCode>
                  <c:ptCount val="6"/>
                  <c:pt idx="0">
                    <c:v>0.35019</c:v>
                  </c:pt>
                  <c:pt idx="1">
                    <c:v>0.25357000000000002</c:v>
                  </c:pt>
                  <c:pt idx="2">
                    <c:v>0.18520000000000031</c:v>
                  </c:pt>
                  <c:pt idx="3">
                    <c:v>0.18520000000000031</c:v>
                  </c:pt>
                  <c:pt idx="4">
                    <c:v>0.25166000000000005</c:v>
                  </c:pt>
                  <c:pt idx="5">
                    <c:v>6.0830000000000023E-2</c:v>
                  </c:pt>
                </c:numCache>
              </c:numRef>
            </c:minus>
          </c:errBars>
          <c:cat>
            <c:numRef>
              <c:f>'1'!$J$2:$J$7</c:f>
              <c:numCache>
                <c:formatCode>General</c:formatCode>
                <c:ptCount val="6"/>
                <c:pt idx="0">
                  <c:v>50</c:v>
                </c:pt>
                <c:pt idx="1">
                  <c:v>100</c:v>
                </c:pt>
                <c:pt idx="2">
                  <c:v>150</c:v>
                </c:pt>
                <c:pt idx="3">
                  <c:v>200</c:v>
                </c:pt>
                <c:pt idx="4">
                  <c:v>250</c:v>
                </c:pt>
                <c:pt idx="5">
                  <c:v>350</c:v>
                </c:pt>
              </c:numCache>
            </c:numRef>
          </c:cat>
          <c:val>
            <c:numRef>
              <c:f>'1'!$K$2:$K$7</c:f>
              <c:numCache>
                <c:formatCode>General</c:formatCode>
                <c:ptCount val="6"/>
                <c:pt idx="0">
                  <c:v>7.2433000000000014</c:v>
                </c:pt>
                <c:pt idx="1">
                  <c:v>10.11</c:v>
                </c:pt>
                <c:pt idx="2">
                  <c:v>12.11</c:v>
                </c:pt>
                <c:pt idx="3">
                  <c:v>13.71</c:v>
                </c:pt>
                <c:pt idx="4">
                  <c:v>11.033300000000001</c:v>
                </c:pt>
                <c:pt idx="5">
                  <c:v>9.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28-4A63-AD6A-656805608A70}"/>
            </c:ext>
          </c:extLst>
        </c:ser>
        <c:ser>
          <c:idx val="1"/>
          <c:order val="1"/>
          <c:tx>
            <c:strRef>
              <c:f>'1'!$L$1</c:f>
              <c:strCache>
                <c:ptCount val="1"/>
                <c:pt idx="0">
                  <c:v>Treated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square"/>
            <c:size val="4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'!$L$11:$L$16</c:f>
                <c:numCache>
                  <c:formatCode>General</c:formatCode>
                  <c:ptCount val="6"/>
                  <c:pt idx="0">
                    <c:v>8.5440000000000002E-2</c:v>
                  </c:pt>
                  <c:pt idx="1">
                    <c:v>0.14731000000000027</c:v>
                  </c:pt>
                  <c:pt idx="2">
                    <c:v>0.20518</c:v>
                  </c:pt>
                  <c:pt idx="3">
                    <c:v>0.26458000000000031</c:v>
                  </c:pt>
                  <c:pt idx="4">
                    <c:v>0.18520000000000031</c:v>
                  </c:pt>
                  <c:pt idx="5">
                    <c:v>0.18248000000000031</c:v>
                  </c:pt>
                </c:numCache>
              </c:numRef>
            </c:plus>
            <c:minus>
              <c:numRef>
                <c:f>'1'!$L$11:$L$16</c:f>
                <c:numCache>
                  <c:formatCode>General</c:formatCode>
                  <c:ptCount val="6"/>
                  <c:pt idx="0">
                    <c:v>8.5440000000000002E-2</c:v>
                  </c:pt>
                  <c:pt idx="1">
                    <c:v>0.14731000000000027</c:v>
                  </c:pt>
                  <c:pt idx="2">
                    <c:v>0.20518</c:v>
                  </c:pt>
                  <c:pt idx="3">
                    <c:v>0.26458000000000031</c:v>
                  </c:pt>
                  <c:pt idx="4">
                    <c:v>0.18520000000000031</c:v>
                  </c:pt>
                  <c:pt idx="5">
                    <c:v>0.18248000000000031</c:v>
                  </c:pt>
                </c:numCache>
              </c:numRef>
            </c:minus>
          </c:errBars>
          <c:cat>
            <c:numRef>
              <c:f>'1'!$J$2:$J$7</c:f>
              <c:numCache>
                <c:formatCode>General</c:formatCode>
                <c:ptCount val="6"/>
                <c:pt idx="0">
                  <c:v>50</c:v>
                </c:pt>
                <c:pt idx="1">
                  <c:v>100</c:v>
                </c:pt>
                <c:pt idx="2">
                  <c:v>150</c:v>
                </c:pt>
                <c:pt idx="3">
                  <c:v>200</c:v>
                </c:pt>
                <c:pt idx="4">
                  <c:v>250</c:v>
                </c:pt>
                <c:pt idx="5">
                  <c:v>350</c:v>
                </c:pt>
              </c:numCache>
            </c:numRef>
          </c:cat>
          <c:val>
            <c:numRef>
              <c:f>'1'!$L$2:$L$7</c:f>
              <c:numCache>
                <c:formatCode>General</c:formatCode>
                <c:ptCount val="6"/>
                <c:pt idx="0">
                  <c:v>5.1099999999999985</c:v>
                </c:pt>
                <c:pt idx="1">
                  <c:v>6.2700000000000014</c:v>
                </c:pt>
                <c:pt idx="2">
                  <c:v>8.11</c:v>
                </c:pt>
                <c:pt idx="3">
                  <c:v>8.9</c:v>
                </c:pt>
                <c:pt idx="4">
                  <c:v>7.31</c:v>
                </c:pt>
                <c:pt idx="5">
                  <c:v>6.60999999999999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28-4A63-AD6A-656805608A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9304064"/>
        <c:axId val="89855872"/>
      </c:lineChart>
      <c:catAx>
        <c:axId val="893040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Ci</a:t>
                </a:r>
                <a:r>
                  <a:rPr lang="en-US" baseline="0"/>
                  <a:t>  (mg/l)</a:t>
                </a:r>
                <a:endParaRPr lang="en-US"/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9855872"/>
        <c:crosses val="autoZero"/>
        <c:auto val="1"/>
        <c:lblAlgn val="ctr"/>
        <c:lblOffset val="100"/>
        <c:noMultiLvlLbl val="0"/>
      </c:catAx>
      <c:valAx>
        <c:axId val="898558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q (mg/g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9304064"/>
        <c:crosses val="autoZero"/>
        <c:crossBetween val="between"/>
      </c:valAx>
      <c:spPr>
        <a:noFill/>
        <a:ln>
          <a:solidFill>
            <a:sysClr val="windowText" lastClr="000000"/>
          </a:solidFill>
        </a:ln>
      </c:spPr>
    </c:plotArea>
    <c:legend>
      <c:legendPos val="t"/>
      <c:overlay val="0"/>
      <c:spPr>
        <a:noFill/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2'!$K$1</c:f>
              <c:strCache>
                <c:ptCount val="1"/>
                <c:pt idx="0">
                  <c:v>Native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'!$K$11:$K$16</c:f>
                <c:numCache>
                  <c:formatCode>General</c:formatCode>
                  <c:ptCount val="6"/>
                  <c:pt idx="0">
                    <c:v>0.34641000000000038</c:v>
                  </c:pt>
                  <c:pt idx="1">
                    <c:v>0.45826</c:v>
                  </c:pt>
                  <c:pt idx="2">
                    <c:v>0.45826</c:v>
                  </c:pt>
                  <c:pt idx="3">
                    <c:v>0.49497000000000074</c:v>
                  </c:pt>
                  <c:pt idx="4">
                    <c:v>0.2</c:v>
                  </c:pt>
                  <c:pt idx="5">
                    <c:v>5.7740000000000014E-2</c:v>
                  </c:pt>
                </c:numCache>
              </c:numRef>
            </c:plus>
            <c:minus>
              <c:numRef>
                <c:f>'2'!$K$11:$K$16</c:f>
                <c:numCache>
                  <c:formatCode>General</c:formatCode>
                  <c:ptCount val="6"/>
                  <c:pt idx="0">
                    <c:v>0.34641000000000038</c:v>
                  </c:pt>
                  <c:pt idx="1">
                    <c:v>0.45826</c:v>
                  </c:pt>
                  <c:pt idx="2">
                    <c:v>0.45826</c:v>
                  </c:pt>
                  <c:pt idx="3">
                    <c:v>0.49497000000000074</c:v>
                  </c:pt>
                  <c:pt idx="4">
                    <c:v>0.2</c:v>
                  </c:pt>
                  <c:pt idx="5">
                    <c:v>5.7740000000000014E-2</c:v>
                  </c:pt>
                </c:numCache>
              </c:numRef>
            </c:minus>
          </c:errBars>
          <c:cat>
            <c:numRef>
              <c:f>'2'!$J$2:$J$7</c:f>
              <c:numCache>
                <c:formatCode>General</c:formatCode>
                <c:ptCount val="6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</c:numCache>
            </c:numRef>
          </c:cat>
          <c:val>
            <c:numRef>
              <c:f>'2'!$K$2:$K$7</c:f>
              <c:numCache>
                <c:formatCode>General</c:formatCode>
                <c:ptCount val="6"/>
                <c:pt idx="0">
                  <c:v>14.1</c:v>
                </c:pt>
                <c:pt idx="1">
                  <c:v>12.2</c:v>
                </c:pt>
                <c:pt idx="2">
                  <c:v>11</c:v>
                </c:pt>
                <c:pt idx="3">
                  <c:v>9.4500000000000028</c:v>
                </c:pt>
                <c:pt idx="4">
                  <c:v>8.9</c:v>
                </c:pt>
                <c:pt idx="5">
                  <c:v>7.6666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729-4D09-AC96-82168A26AE66}"/>
            </c:ext>
          </c:extLst>
        </c:ser>
        <c:ser>
          <c:idx val="1"/>
          <c:order val="1"/>
          <c:tx>
            <c:strRef>
              <c:f>'2'!$L$1</c:f>
              <c:strCache>
                <c:ptCount val="1"/>
                <c:pt idx="0">
                  <c:v>Treated biomass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square"/>
            <c:size val="4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2'!$L$11:$L$16</c:f>
                <c:numCache>
                  <c:formatCode>General</c:formatCode>
                  <c:ptCount val="6"/>
                  <c:pt idx="0">
                    <c:v>0.45826</c:v>
                  </c:pt>
                  <c:pt idx="1">
                    <c:v>0.36056000000000032</c:v>
                  </c:pt>
                  <c:pt idx="2">
                    <c:v>0.35355000000000031</c:v>
                  </c:pt>
                  <c:pt idx="3">
                    <c:v>0.41633000000000031</c:v>
                  </c:pt>
                  <c:pt idx="4">
                    <c:v>0.36056000000000032</c:v>
                  </c:pt>
                  <c:pt idx="5">
                    <c:v>0.26458000000000031</c:v>
                  </c:pt>
                </c:numCache>
              </c:numRef>
            </c:plus>
            <c:minus>
              <c:numRef>
                <c:f>'2'!$L$11:$L$16</c:f>
                <c:numCache>
                  <c:formatCode>General</c:formatCode>
                  <c:ptCount val="6"/>
                  <c:pt idx="0">
                    <c:v>0.45826</c:v>
                  </c:pt>
                  <c:pt idx="1">
                    <c:v>0.36056000000000032</c:v>
                  </c:pt>
                  <c:pt idx="2">
                    <c:v>0.35355000000000031</c:v>
                  </c:pt>
                  <c:pt idx="3">
                    <c:v>0.41633000000000031</c:v>
                  </c:pt>
                  <c:pt idx="4">
                    <c:v>0.36056000000000032</c:v>
                  </c:pt>
                  <c:pt idx="5">
                    <c:v>0.26458000000000031</c:v>
                  </c:pt>
                </c:numCache>
              </c:numRef>
            </c:minus>
          </c:errBars>
          <c:cat>
            <c:numRef>
              <c:f>'2'!$J$2:$J$7</c:f>
              <c:numCache>
                <c:formatCode>General</c:formatCode>
                <c:ptCount val="6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</c:numCache>
            </c:numRef>
          </c:cat>
          <c:val>
            <c:numRef>
              <c:f>'2'!$L$2:$L$7</c:f>
              <c:numCache>
                <c:formatCode>General</c:formatCode>
                <c:ptCount val="6"/>
                <c:pt idx="0">
                  <c:v>9.9</c:v>
                </c:pt>
                <c:pt idx="1">
                  <c:v>9</c:v>
                </c:pt>
                <c:pt idx="2">
                  <c:v>8.4500000000000028</c:v>
                </c:pt>
                <c:pt idx="3">
                  <c:v>7.0333000000000014</c:v>
                </c:pt>
                <c:pt idx="4">
                  <c:v>6</c:v>
                </c:pt>
                <c:pt idx="5">
                  <c:v>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729-4D09-AC96-82168A26A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1087616"/>
        <c:axId val="93094656"/>
      </c:lineChart>
      <c:catAx>
        <c:axId val="910876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m</a:t>
                </a:r>
                <a:r>
                  <a:rPr lang="en-US" baseline="0"/>
                  <a:t>  (g/l)</a:t>
                </a:r>
                <a:endParaRPr lang="en-US"/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93094656"/>
        <c:crosses val="autoZero"/>
        <c:auto val="1"/>
        <c:lblAlgn val="ctr"/>
        <c:lblOffset val="100"/>
        <c:noMultiLvlLbl val="0"/>
      </c:catAx>
      <c:valAx>
        <c:axId val="930946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q (mg/g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91087616"/>
        <c:crosses val="autoZero"/>
        <c:crossBetween val="between"/>
      </c:valAx>
      <c:spPr>
        <a:noFill/>
        <a:ln>
          <a:solidFill>
            <a:sysClr val="windowText" lastClr="000000"/>
          </a:solidFill>
        </a:ln>
      </c:spPr>
    </c:plotArea>
    <c:legend>
      <c:legendPos val="t"/>
      <c:overlay val="0"/>
      <c:spPr>
        <a:noFill/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ar-E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ar-E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/>
              <a:t>Click to edit Master title style</a:t>
            </a:r>
            <a:endParaRPr lang="ar-E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A648F-D65E-4BC7-AD0C-7B7A5668E079}" type="datetimeFigureOut">
              <a:rPr lang="ar-EG" smtClean="0"/>
              <a:t>04/09/1441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39DF8-FF1B-4C54-AFF7-B8992369D630}" type="slidenum">
              <a:rPr lang="ar-EG" smtClean="0"/>
              <a:t>‹#›</a:t>
            </a:fld>
            <a:endParaRPr lang="ar-EG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ar-EG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/>
          <p:nvPr>
            <p:extLst>
              <p:ext uri="{D42A27DB-BD31-4B8C-83A1-F6EECF244321}">
                <p14:modId xmlns:p14="http://schemas.microsoft.com/office/powerpoint/2010/main" val="927177290"/>
              </p:ext>
            </p:extLst>
          </p:nvPr>
        </p:nvGraphicFramePr>
        <p:xfrm>
          <a:off x="539552" y="332656"/>
          <a:ext cx="7416824" cy="4320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A1837EE7-FD09-4B11-BCB2-E8F6F5CE449E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934845" y="1873400"/>
          <a:ext cx="5274310" cy="311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0729148-8E66-4E0D-AE4E-36360F69C552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0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934845" y="1873400"/>
          <a:ext cx="5274310" cy="311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0CFC977-AFD2-4B23-BDE1-F77DF05EB467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971829575"/>
              </p:ext>
            </p:extLst>
          </p:nvPr>
        </p:nvGraphicFramePr>
        <p:xfrm>
          <a:off x="1547664" y="404664"/>
          <a:ext cx="5274310" cy="35632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ADB8866-8608-4C00-BE33-35EFC4B0ED74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93213105"/>
              </p:ext>
            </p:extLst>
          </p:nvPr>
        </p:nvGraphicFramePr>
        <p:xfrm>
          <a:off x="1403648" y="692696"/>
          <a:ext cx="5274310" cy="3422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9F8EB64-432B-464E-8774-99E3BF05267E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260880653"/>
              </p:ext>
            </p:extLst>
          </p:nvPr>
        </p:nvGraphicFramePr>
        <p:xfrm>
          <a:off x="755576" y="548680"/>
          <a:ext cx="6552727" cy="38884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2D22DEDB-8ECD-4EAE-BB40-2F4C98D5B9AB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488475326"/>
              </p:ext>
            </p:extLst>
          </p:nvPr>
        </p:nvGraphicFramePr>
        <p:xfrm>
          <a:off x="899592" y="404664"/>
          <a:ext cx="5274310" cy="3422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D4C684F-5053-4D56-9FD4-6FA21679AD5C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78966318"/>
              </p:ext>
            </p:extLst>
          </p:nvPr>
        </p:nvGraphicFramePr>
        <p:xfrm>
          <a:off x="457200" y="836712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88AB3E3-03BB-4F09-BD1C-49462685AF29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209044146"/>
              </p:ext>
            </p:extLst>
          </p:nvPr>
        </p:nvGraphicFramePr>
        <p:xfrm>
          <a:off x="1403648" y="548680"/>
          <a:ext cx="5274310" cy="311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39572F9-863B-40A3-B2A1-C1CDF7B9DEEC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934845" y="1873400"/>
          <a:ext cx="5274310" cy="311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48424423-55AD-4979-831D-E481F38A84DB}"/>
              </a:ext>
            </a:extLst>
          </p:cNvPr>
          <p:cNvSpPr txBox="1"/>
          <p:nvPr/>
        </p:nvSpPr>
        <p:spPr>
          <a:xfrm>
            <a:off x="1619672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934845" y="1873400"/>
          <a:ext cx="5274310" cy="3111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0202C4E-CA96-4DB4-AC3A-E4AB91A74CE4}"/>
              </a:ext>
            </a:extLst>
          </p:cNvPr>
          <p:cNvSpPr txBox="1"/>
          <p:nvPr/>
        </p:nvSpPr>
        <p:spPr>
          <a:xfrm>
            <a:off x="1547664" y="5661248"/>
            <a:ext cx="2088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81</Words>
  <Application>Microsoft Office PowerPoint</Application>
  <PresentationFormat>On-screen Show (4:3)</PresentationFormat>
  <Paragraphs>33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Lenovo</dc:creator>
  <cp:lastModifiedBy>Ashraf</cp:lastModifiedBy>
  <cp:revision>14</cp:revision>
  <dcterms:created xsi:type="dcterms:W3CDTF">2019-09-24T19:44:59Z</dcterms:created>
  <dcterms:modified xsi:type="dcterms:W3CDTF">2020-04-27T07:39:41Z</dcterms:modified>
</cp:coreProperties>
</file>